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2" r:id="rId6"/>
    <p:sldId id="260" r:id="rId7"/>
    <p:sldId id="263" r:id="rId8"/>
    <p:sldId id="261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268" autoAdjust="0"/>
    <p:restoredTop sz="74591" autoAdjust="0"/>
  </p:normalViewPr>
  <p:slideViewPr>
    <p:cSldViewPr snapToGrid="0">
      <p:cViewPr varScale="1">
        <p:scale>
          <a:sx n="85" d="100"/>
          <a:sy n="85" d="100"/>
        </p:scale>
        <p:origin x="8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FCE27D-A7DE-45E0-BF38-5D414405B6B0}" type="datetimeFigureOut">
              <a:rPr lang="en-US" smtClean="0"/>
              <a:t>12/30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8709DB-199F-42C5-B5F0-8CDA4AF56E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8052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is slide deck is to be used by educators as a complement to our PTA model. Users are freely allowed to make adjustments to their learner’s needs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8709DB-199F-42C5-B5F0-8CDA4AF56E1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4579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8709DB-199F-42C5-B5F0-8CDA4AF56E1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0730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8709DB-199F-42C5-B5F0-8CDA4AF56E1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85542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8709DB-199F-42C5-B5F0-8CDA4AF56E1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0986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7BD522-CBA5-41E2-8123-7CEABB9AEB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1E2FD6-D83B-4F3E-A2B8-42A739C6E3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D031CF-BBB3-4002-A8D8-774D68C21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337A19-4D01-4EC8-9078-813D6D0AB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69E9BB-00A6-4134-9CEC-B004B75F2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7228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774360-B42D-424D-BB38-CA6F3BF67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088A48-F77B-4C34-A2C0-FC1E896014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2C77C3-8463-4A8C-B3E9-3845187C5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8B495A-6555-42EC-AA00-2A3818BE2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A6947B-45F9-4C77-88E3-7B2E283C2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51790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DB0273C-26F8-43DC-B0B8-F1BC849774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FFA27D-AA33-4243-B450-3931561629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875943-6E59-4A47-9AA9-DDCB50CDE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886E5C-599F-4595-8CBD-CC7AFBEDA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AD0933-72CE-4128-9A74-7D6EDE974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4901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5B76E2-C064-42D5-8494-F98417502B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4B5EDC-3755-4712-81B8-8BD4744360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D751D0-715A-4075-AD92-3C17B5BFB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E7B090-FF61-45FB-A6E4-F01A80B9F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AAD1FA-3926-4F17-8271-404AD5029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00584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CFBB8A-9768-4BED-A9E3-F2466A85CC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55C088-1C47-4A65-96C0-8BEEC0DC0F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934CAC-CB5F-45CB-9F32-533EA4044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B48FD7-8CB7-4834-A61B-2A88754DE6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8D18AC-A047-4F8F-8338-6CB5CB74B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2733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1EA812-B30B-4EAC-B699-6B6A43D8D2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55610B-540F-4DFD-A965-8074E677AC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399CE7-0C4A-492E-BD8D-84AD14C55F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786DB6-C87F-4770-B931-35C774912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233060-1733-4119-B621-F740BF59B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015E13-1D26-47FA-BF66-F406B1DFC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7166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9A0669-B1EA-4AB8-ABE7-80760BF376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DEC5A4-1172-49C9-80FD-AA018799B2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B4DB65-AAA8-4725-B941-CDD3AA2590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1A64D1-089E-46BC-965D-86FE36D66B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5CB9C0C-2A8E-44C7-A008-FA1A9A00BD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AFD1B6-4B8E-4786-819E-2445221AA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727E795-286F-40ED-9AA9-E2C2D4C8D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E85DDE-FB84-4CEA-BBED-8DC13B448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3763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D56A72-B892-47C9-B041-D9A4400D50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D6C457-35E2-4C44-8DBD-6F434A2FB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CFCA19-B8BF-41B4-B50C-FF80573FD0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0EC7200-FC29-4D79-AE92-05C9AD5C2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2726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01EA5A-5B7A-43B8-BF58-7834177FE0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2D84978-A4D7-4CC2-B962-4C781CC91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41A524C-364A-4356-A5DD-BE2F413D1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1738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A6486D-D764-4C56-92AC-8E1BA2024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8D0CBE-A380-4DF0-AB22-0BCB26B7CB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6D0150-5DE1-4649-AE1B-6C9C43E7AE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0C41E5-C14D-4634-B3AC-A8E90E43C7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BBB238-E867-4078-B702-52D3F3595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39FE81-E946-42C8-B0C6-41D52FB27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1241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65E226-7753-4D80-9682-3B5AC76F11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436BF04-1A68-47B6-A5CC-ADC45BC503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4CE3E2-5D83-4C03-9412-BCAA459142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644FEC-4261-4BE0-90B0-8204CC0AC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CE16DD-EE03-4A35-96D0-8AAB19F7F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50AD97-6F1B-44A3-9184-7AF901129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0579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BCD255-24D1-48F0-827F-B1B8681F22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00038C-7C4A-4BA1-B865-C0522C60DB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D8CF9B-1521-44AE-9849-4D8B184ACA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A12D3C-2169-4785-9B47-1D4598965BAD}" type="datetimeFigureOut">
              <a:rPr lang="en-US" smtClean="0"/>
              <a:t>12/30/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4F6E43-A7CB-4C80-9B2E-D82590563F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0ABC5E-8698-42C9-BACF-492B742898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4EBE1-F861-41AD-8E3D-2378A391ADE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1144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jpe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hyperlink" Target="https://coreem.net/core/peritonsillar-abscess/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E37E5C-30C5-4623-A928-071E497BD4F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Peritonsillar Abscess for the Emergency Physician</a:t>
            </a:r>
          </a:p>
        </p:txBody>
      </p:sp>
      <p:sp>
        <p:nvSpPr>
          <p:cNvPr id="5" name="Subtitle 4">
            <a:extLst>
              <a:ext uri="{FF2B5EF4-FFF2-40B4-BE49-F238E27FC236}">
                <a16:creationId xmlns:a16="http://schemas.microsoft.com/office/drawing/2014/main" id="{F7D358BF-E812-41C7-AD87-649932936C9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Mustafa Rasheed, Keel Coleman D.O., Timothy Fortuna D.O.</a:t>
            </a:r>
          </a:p>
        </p:txBody>
      </p:sp>
      <p:pic>
        <p:nvPicPr>
          <p:cNvPr id="4" name="Picture 8">
            <a:extLst>
              <a:ext uri="{FF2B5EF4-FFF2-40B4-BE49-F238E27FC236}">
                <a16:creationId xmlns:a16="http://schemas.microsoft.com/office/drawing/2014/main" id="{65695C43-2597-BE44-B877-BD470BE49B4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5418" y="6277157"/>
            <a:ext cx="1462088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671255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F8A91A-46CE-417A-AD78-AE3F2E3238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eritonsillar Absces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5F216B-F9D7-425F-9D78-983603F2C6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19275"/>
            <a:ext cx="6089650" cy="4351338"/>
          </a:xfrm>
        </p:spPr>
        <p:txBody>
          <a:bodyPr>
            <a:normAutofit fontScale="92500" lnSpcReduction="20000"/>
          </a:bodyPr>
          <a:lstStyle/>
          <a:p>
            <a:r>
              <a:rPr lang="en-US" dirty="0"/>
              <a:t>The most common deep neck infection</a:t>
            </a:r>
          </a:p>
          <a:p>
            <a:r>
              <a:rPr lang="en-US" dirty="0"/>
              <a:t>Transepithelial migration of bacteria into the potential space bounded by the capsule of the palatine tonsils and constrictor muscles of the pharynx</a:t>
            </a:r>
          </a:p>
          <a:p>
            <a:pPr lvl="1"/>
            <a:r>
              <a:rPr lang="en-US" dirty="0"/>
              <a:t>Commonly in the superior pole</a:t>
            </a:r>
          </a:p>
          <a:p>
            <a:pPr lvl="1"/>
            <a:r>
              <a:rPr lang="en-US" dirty="0"/>
              <a:t>Group A strep, </a:t>
            </a:r>
            <a:r>
              <a:rPr lang="en-US" i="1" dirty="0"/>
              <a:t>Streptococcus anginosus</a:t>
            </a:r>
            <a:r>
              <a:rPr lang="en-US" dirty="0"/>
              <a:t>, </a:t>
            </a:r>
            <a:r>
              <a:rPr lang="en-US" i="1" dirty="0"/>
              <a:t>Staphylococcus aureus </a:t>
            </a:r>
            <a:r>
              <a:rPr lang="en-US" dirty="0"/>
              <a:t>(including MRSA), and respiratory anaerobes (</a:t>
            </a:r>
            <a:r>
              <a:rPr lang="en-US" i="1" dirty="0"/>
              <a:t>Fusobacteria</a:t>
            </a:r>
            <a:r>
              <a:rPr lang="en-US" dirty="0"/>
              <a:t>, P</a:t>
            </a:r>
            <a:r>
              <a:rPr lang="en-US" i="1" dirty="0"/>
              <a:t>revotella</a:t>
            </a:r>
            <a:r>
              <a:rPr lang="en-US" dirty="0"/>
              <a:t>, and </a:t>
            </a:r>
            <a:r>
              <a:rPr lang="en-US" i="1" dirty="0"/>
              <a:t>Veillonella </a:t>
            </a:r>
            <a:r>
              <a:rPr lang="en-US" dirty="0"/>
              <a:t>species)</a:t>
            </a:r>
          </a:p>
          <a:p>
            <a:r>
              <a:rPr lang="en-US" dirty="0"/>
              <a:t>Two Hypothesis: </a:t>
            </a:r>
          </a:p>
          <a:p>
            <a:pPr lvl="1"/>
            <a:r>
              <a:rPr lang="en-US" dirty="0"/>
              <a:t>Tonsillitis or pharyngitis leads to cellulitis and ultimately peritonsillar abscess (PTA)</a:t>
            </a:r>
          </a:p>
          <a:p>
            <a:pPr lvl="1"/>
            <a:r>
              <a:rPr lang="en-US" dirty="0"/>
              <a:t>Weber Gland Hypothesis 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7614608-DD58-4BF1-A0BE-84294201488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6297" y="105093"/>
            <a:ext cx="4568095" cy="606552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6310DDC5-732A-4D27-969D-491E4E76030E}"/>
              </a:ext>
            </a:extLst>
          </p:cNvPr>
          <p:cNvSpPr/>
          <p:nvPr/>
        </p:nvSpPr>
        <p:spPr>
          <a:xfrm>
            <a:off x="7223336" y="6138257"/>
            <a:ext cx="506522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Figure 1. Oropharynx anatomy. In: Cunningham DJ, Robinson A. Cunningham's Textbook of Anatomy. 4th ed. New York: Columbia University Libraries; 1914. Page 1117.  Public domain.</a:t>
            </a:r>
          </a:p>
        </p:txBody>
      </p:sp>
    </p:spTree>
    <p:extLst>
      <p:ext uri="{BB962C8B-B14F-4D97-AF65-F5344CB8AC3E}">
        <p14:creationId xmlns:p14="http://schemas.microsoft.com/office/powerpoint/2010/main" val="42196340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F323EE-DE7C-4C7B-8056-431A9119A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sent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8721DD-294F-463E-83C6-82D8AABC80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6568016" cy="4351338"/>
          </a:xfrm>
        </p:spPr>
        <p:txBody>
          <a:bodyPr/>
          <a:lstStyle/>
          <a:p>
            <a:r>
              <a:rPr lang="en-US" dirty="0"/>
              <a:t>Mainly in young adults: 20-40s</a:t>
            </a:r>
          </a:p>
          <a:p>
            <a:r>
              <a:rPr lang="en-US" dirty="0"/>
              <a:t>Risk Factors: male (3:1), periodontal disease, smoking, immunocompromised </a:t>
            </a:r>
          </a:p>
          <a:p>
            <a:r>
              <a:rPr lang="en-US" dirty="0"/>
              <a:t>Symptoms: Fever, sore throat, drooling, dysphagia, ear pain</a:t>
            </a:r>
          </a:p>
          <a:p>
            <a:r>
              <a:rPr lang="en-US" dirty="0"/>
              <a:t>Physical Exam: trismus, “hot potato” voice, unilateral tonsillar swelling, cervical lymphadenopathy</a:t>
            </a:r>
          </a:p>
          <a:p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354018B-F1C8-4695-96E8-0DD8C907EE58}"/>
              </a:ext>
            </a:extLst>
          </p:cNvPr>
          <p:cNvSpPr/>
          <p:nvPr/>
        </p:nvSpPr>
        <p:spPr>
          <a:xfrm>
            <a:off x="7348261" y="5023709"/>
            <a:ext cx="461621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Figure 2.Patient with right-sided peritonsillar abscess. Note soft palate swelling and appearance of abscess. In:</a:t>
            </a:r>
          </a:p>
          <a:p>
            <a:r>
              <a:rPr lang="en-US" sz="800" dirty="0"/>
              <a:t>Heilman J. PeritonsilarAbsess.jpg. Commons Wikimedia. https://commons.wikimedia.org/wiki/File:PeritonsilarAbsess.jpg. Published May 13, 2011. Accessed October 1, 2019. CC-BY-SA-3.0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BBA358B5-20B4-4FD7-B234-074F3F5E2D5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65777" y="785611"/>
            <a:ext cx="3581180" cy="41897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294548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3C78A4-F5F8-4A3F-8E67-F23A7BE6FF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echniqu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C2EBA3-8BF0-4351-AD3E-C51958E82A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1" y="1825624"/>
            <a:ext cx="6199907" cy="4727575"/>
          </a:xfrm>
        </p:spPr>
        <p:txBody>
          <a:bodyPr>
            <a:normAutofit fontScale="85000" lnSpcReduction="20000"/>
          </a:bodyPr>
          <a:lstStyle/>
          <a:p>
            <a:r>
              <a:rPr lang="en-US" dirty="0"/>
              <a:t>Proper technique is required to avoid complications such as airway compromise, aspiration, extension of infection, hemorrhage due to carotid vessel damage </a:t>
            </a:r>
          </a:p>
          <a:p>
            <a:r>
              <a:rPr lang="en-US" dirty="0"/>
              <a:t>Patient in seated position with suction and a spit basin available to reduce aspiration</a:t>
            </a:r>
          </a:p>
          <a:p>
            <a:r>
              <a:rPr lang="en-US" dirty="0"/>
              <a:t>Utilize a tongue depressor or Mac blade to increase visibility </a:t>
            </a:r>
          </a:p>
          <a:p>
            <a:r>
              <a:rPr lang="en-US" dirty="0"/>
              <a:t>Local Anesthetic: nebulized lidocaine, benzocaine spray, or injected anesthetics</a:t>
            </a:r>
          </a:p>
          <a:p>
            <a:r>
              <a:rPr lang="en-US" dirty="0"/>
              <a:t>5-10mHz curved array endocavitary probe should be used with probe cover</a:t>
            </a:r>
          </a:p>
          <a:p>
            <a:pPr lvl="1"/>
            <a:r>
              <a:rPr lang="en-US" dirty="0"/>
              <a:t>No external gel required </a:t>
            </a:r>
          </a:p>
          <a:p>
            <a:pPr lvl="1"/>
            <a:r>
              <a:rPr lang="en-US" dirty="0"/>
              <a:t>May use small linear probe or transcutaneous approach under the mandible if needed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0C1E162-D524-4DAA-BF6A-CF70A4BFCA34}"/>
              </a:ext>
            </a:extLst>
          </p:cNvPr>
          <p:cNvSpPr/>
          <p:nvPr/>
        </p:nvSpPr>
        <p:spPr>
          <a:xfrm>
            <a:off x="7877244" y="5881426"/>
            <a:ext cx="417641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ase"/>
            <a:r>
              <a:rPr lang="en-US" sz="800" dirty="0">
                <a:solidFill>
                  <a:srgbClr val="000000"/>
                </a:solidFill>
              </a:rPr>
              <a:t>FIGURE 3A, 3B, 3C. Patient Positioning and Visualization. Author’s own image.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FECF810-A479-40BD-9563-7D689F7CA46E}"/>
              </a:ext>
            </a:extLst>
          </p:cNvPr>
          <p:cNvSpPr/>
          <p:nvPr/>
        </p:nvSpPr>
        <p:spPr>
          <a:xfrm>
            <a:off x="7038108" y="3003328"/>
            <a:ext cx="484354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br>
              <a:rPr lang="en-US" sz="800" dirty="0">
                <a:latin typeface="+mj-lt"/>
              </a:rPr>
            </a:br>
            <a:endParaRPr lang="en-US" sz="800" dirty="0">
              <a:latin typeface="+mj-lt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9F3A658-2248-4F90-A63C-AEB85E314C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22490" y="804354"/>
            <a:ext cx="2760952" cy="2286000"/>
          </a:xfrm>
          <a:prstGeom prst="rect">
            <a:avLst/>
          </a:prstGeom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id="{C02B227E-FFD3-49C0-BC5A-D92EF523A33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18" t="14455" r="24412"/>
          <a:stretch/>
        </p:blipFill>
        <p:spPr bwMode="auto">
          <a:xfrm>
            <a:off x="9713320" y="802397"/>
            <a:ext cx="2493190" cy="228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663A01D-6314-4FF0-B9F9-9660A8BA5B9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6900" r="24572"/>
          <a:stretch/>
        </p:blipFill>
        <p:spPr>
          <a:xfrm>
            <a:off x="7372985" y="3373724"/>
            <a:ext cx="4680671" cy="25077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83736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6B34EE14-78AF-4D58-B9E8-64013930ABD4}"/>
              </a:ext>
            </a:extLst>
          </p:cNvPr>
          <p:cNvSpPr/>
          <p:nvPr/>
        </p:nvSpPr>
        <p:spPr>
          <a:xfrm>
            <a:off x="-158750" y="-8041"/>
            <a:ext cx="12350750" cy="6923191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E3F5868-EDB2-44A4-BDAE-552EDD69B9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6480" y="-8041"/>
            <a:ext cx="10283216" cy="687416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CEF8758-B989-46C0-AC99-F414DF73905C}"/>
              </a:ext>
            </a:extLst>
          </p:cNvPr>
          <p:cNvSpPr txBox="1"/>
          <p:nvPr/>
        </p:nvSpPr>
        <p:spPr>
          <a:xfrm>
            <a:off x="7898450" y="6675192"/>
            <a:ext cx="47647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Peritonsillar Abscesses Photo courtesy of Dr. John Nogueira, Carilion Clinic Emergency Medicine.</a:t>
            </a:r>
          </a:p>
        </p:txBody>
      </p:sp>
    </p:spTree>
    <p:extLst>
      <p:ext uri="{BB962C8B-B14F-4D97-AF65-F5344CB8AC3E}">
        <p14:creationId xmlns:p14="http://schemas.microsoft.com/office/powerpoint/2010/main" val="6252429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5BEC72-34E3-4392-A381-C6776551C2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ltrasou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DC78FD-5E6C-4924-AD09-9BA061E60A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5603130" cy="4351338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Intraoral sensitivity ranges from 90% -95% </a:t>
            </a:r>
          </a:p>
          <a:p>
            <a:pPr lvl="1"/>
            <a:r>
              <a:rPr lang="en-US" dirty="0"/>
              <a:t>transcutaneous sensitivity ranges from 80% - 91%</a:t>
            </a:r>
          </a:p>
          <a:p>
            <a:r>
              <a:rPr lang="en-US" dirty="0"/>
              <a:t>Consider cellulitis if no fluid visualized </a:t>
            </a:r>
          </a:p>
          <a:p>
            <a:r>
              <a:rPr lang="en-US" dirty="0"/>
              <a:t>Measure distance to abscess and carotid</a:t>
            </a:r>
          </a:p>
          <a:p>
            <a:pPr lvl="1"/>
            <a:r>
              <a:rPr lang="en-US" dirty="0"/>
              <a:t>Cut 1 cm off plastic needle guard to decrease vessel perforation</a:t>
            </a:r>
          </a:p>
          <a:p>
            <a:r>
              <a:rPr lang="en-US" dirty="0"/>
              <a:t>Aspirate the superior pole</a:t>
            </a:r>
          </a:p>
          <a:p>
            <a:pPr lvl="1"/>
            <a:r>
              <a:rPr lang="en-US" dirty="0"/>
              <a:t>Use a spinal needle</a:t>
            </a:r>
          </a:p>
          <a:p>
            <a:pPr lvl="1"/>
            <a:r>
              <a:rPr lang="en-US" dirty="0"/>
              <a:t>Usually 2 - 6 mL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A4E7EA0-FBD4-463E-95B8-5CA293027D99}"/>
              </a:ext>
            </a:extLst>
          </p:cNvPr>
          <p:cNvSpPr/>
          <p:nvPr/>
        </p:nvSpPr>
        <p:spPr>
          <a:xfrm>
            <a:off x="7753028" y="2768666"/>
            <a:ext cx="338563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ase"/>
            <a:r>
              <a:rPr lang="en-US" sz="800" dirty="0">
                <a:solidFill>
                  <a:srgbClr val="000000"/>
                </a:solidFill>
              </a:rPr>
              <a:t>FIGURE 5. Needle Preparation Author’s own image. </a:t>
            </a:r>
            <a:endParaRPr lang="en-US" sz="8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ADFCD9B-8808-468D-B6F7-2FAF270400B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674" b="17150"/>
          <a:stretch/>
        </p:blipFill>
        <p:spPr>
          <a:xfrm>
            <a:off x="8577329" y="30300"/>
            <a:ext cx="1869721" cy="2738366"/>
          </a:xfrm>
          <a:prstGeom prst="rect">
            <a:avLst/>
          </a:prstGeom>
        </p:spPr>
      </p:pic>
      <p:pic>
        <p:nvPicPr>
          <p:cNvPr id="2050" name="Picture 2">
            <a:extLst>
              <a:ext uri="{FF2B5EF4-FFF2-40B4-BE49-F238E27FC236}">
                <a16:creationId xmlns:a16="http://schemas.microsoft.com/office/drawing/2014/main" id="{69631EFD-E04F-48B5-B8FA-916113ACD1B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30" t="12931" r="10223" b="20987"/>
          <a:stretch/>
        </p:blipFill>
        <p:spPr bwMode="auto">
          <a:xfrm>
            <a:off x="6285541" y="3575241"/>
            <a:ext cx="5906459" cy="28913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4468A04A-2395-437A-BAFA-BED83D997352}"/>
              </a:ext>
            </a:extLst>
          </p:cNvPr>
          <p:cNvSpPr/>
          <p:nvPr/>
        </p:nvSpPr>
        <p:spPr>
          <a:xfrm>
            <a:off x="7370954" y="6446912"/>
            <a:ext cx="338563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ase"/>
            <a:r>
              <a:rPr lang="en-US" sz="800" dirty="0">
                <a:solidFill>
                  <a:srgbClr val="000000"/>
                </a:solidFill>
              </a:rPr>
              <a:t>FIGURE 6. PTA drainage with ultrasound. 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6280252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8BCF5A-431B-4966-A1FD-91390DAEDB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posi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DFD95C-5F39-4AAE-9D06-266ED31269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6644425" cy="4343355"/>
          </a:xfrm>
        </p:spPr>
        <p:txBody>
          <a:bodyPr>
            <a:normAutofit lnSpcReduction="10000"/>
          </a:bodyPr>
          <a:lstStyle/>
          <a:p>
            <a:r>
              <a:rPr lang="en-US" dirty="0"/>
              <a:t>Admit if septic, concerns of airway patency, pediatric patient, outpatient treatment failure </a:t>
            </a:r>
          </a:p>
          <a:p>
            <a:r>
              <a:rPr lang="en-US" dirty="0"/>
              <a:t>Antibiotics</a:t>
            </a:r>
          </a:p>
          <a:p>
            <a:pPr lvl="1"/>
            <a:r>
              <a:rPr lang="en-US" dirty="0"/>
              <a:t>IV: Ampicillin/sulbactam or Penicillin G + metronidazole </a:t>
            </a:r>
          </a:p>
          <a:p>
            <a:pPr lvl="1"/>
            <a:r>
              <a:rPr lang="en-US" dirty="0"/>
              <a:t>Oral: Amoxicillin/clavulanic acid, clindamycin, Penicillin VK </a:t>
            </a:r>
          </a:p>
          <a:p>
            <a:r>
              <a:rPr lang="en-US" dirty="0"/>
              <a:t>Adjuvant corticosteroid therapy support is inconsistent </a:t>
            </a:r>
          </a:p>
          <a:p>
            <a:r>
              <a:rPr lang="en-US" dirty="0"/>
              <a:t>Follow up with otolaryngology </a:t>
            </a:r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3BC6CE32-9A0D-4C8D-B24D-301A1EEAA2A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24" t="1610" r="13547" b="13693"/>
          <a:stretch/>
        </p:blipFill>
        <p:spPr bwMode="auto">
          <a:xfrm>
            <a:off x="7418818" y="1453387"/>
            <a:ext cx="4766740" cy="26485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ECF481C8-87E9-43E0-AB0A-8E047C058C49}"/>
              </a:ext>
            </a:extLst>
          </p:cNvPr>
          <p:cNvSpPr/>
          <p:nvPr/>
        </p:nvSpPr>
        <p:spPr>
          <a:xfrm>
            <a:off x="8780915" y="4101918"/>
            <a:ext cx="20425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 fontAlgn="base"/>
            <a:r>
              <a:rPr lang="en-US" sz="800" dirty="0">
                <a:solidFill>
                  <a:srgbClr val="000000"/>
                </a:solidFill>
              </a:rPr>
              <a:t>FIGURE 7. PTA drainage without ultrasound. </a:t>
            </a:r>
            <a:endParaRPr lang="en-US" sz="8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49873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3A0D10-B52D-46DC-961A-62CE507307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: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6672CC-A48E-475E-8AF9-AD417E78BA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000250"/>
            <a:ext cx="10515600" cy="4806949"/>
          </a:xfrm>
        </p:spPr>
        <p:txBody>
          <a:bodyPr>
            <a:normAutofit fontScale="47500" lnSpcReduction="20000"/>
          </a:bodyPr>
          <a:lstStyle/>
          <a:p>
            <a:pPr marL="514350" lvl="0" indent="-514350">
              <a:buFont typeface="+mj-lt"/>
              <a:buAutoNum type="arabicPeriod"/>
            </a:pPr>
            <a:r>
              <a:rPr lang="en-US" dirty="0"/>
              <a:t>Oropharynx anatomy. In: Cunningham DJ, Robinson A</a:t>
            </a:r>
            <a:r>
              <a:rPr lang="en-US" i="1" dirty="0"/>
              <a:t>. Cunningham's Textbook of Anatomy</a:t>
            </a:r>
            <a:r>
              <a:rPr lang="en-US" dirty="0"/>
              <a:t>. 4th ed. New York: Columbia University Libraries; 1914. Page 1117. 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/>
              <a:t>Heilman J. PeritonsilarAbsess.jpg. Commons Wikimedia. https://commons.wikimedia.org/wiki/File:PeritonsilarAbsess.jpg. Published May 13, 2011. Accessed October 1, 2019. CC-BY-SA-3.0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Coneybeare D. Peritonsillar Abscess – Core EM Podcast. June 9, 2015. </a:t>
            </a:r>
            <a:r>
              <a:rPr lang="en-US" dirty="0">
                <a:hlinkClick r:id="rId2"/>
              </a:rPr>
              <a:t>https://coreem.net/core/peritonsillar-abscess/</a:t>
            </a:r>
            <a:r>
              <a:rPr lang="en-US" dirty="0"/>
              <a:t>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Galioto NJ. Peritonsillar abscess. Am Fam Physician. 2017 Apr 15;95(8):501-506. https://www.aafp.org/afp/2017/0415/p501.html. Accessed May 19, 2019. 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Klug, TE, Rusan M, Fuursted K, and Ovesen T. Peritonsillar Abscess: Complication of Acute Tonsillitis or Weber’s Glands Infection? </a:t>
            </a:r>
            <a:r>
              <a:rPr lang="en-US" i="1" dirty="0"/>
              <a:t>Otolaryngology--Head and Neck Surgery</a:t>
            </a:r>
            <a:r>
              <a:rPr lang="en-US" dirty="0"/>
              <a:t>. 155, no. 2 (2016): 199–207.  DOI: 10.1177/0194599816639551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Lecuyer, Matthew. </a:t>
            </a:r>
            <a:r>
              <a:rPr lang="en-US" dirty="0">
                <a:effectLst/>
              </a:rPr>
              <a:t>“What Is That Hot Potato Voice? POCUS for the PTA.” Brown Emergency Medicine Blog. http://brownemblog.com/blog-1/2019/4/24/ptaultrasound</a:t>
            </a:r>
            <a:r>
              <a:rPr lang="en-US" dirty="0"/>
              <a:t>. Accessed May 15, 2019. 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Lyon M, and Blaivas Ml. Intraoral Ultrasound in the Diagnosis and Treatment of Suspected Peritonsillar Abscess in the Emergency Department. </a:t>
            </a:r>
            <a:r>
              <a:rPr lang="en-US" i="1" dirty="0"/>
              <a:t>Academic Emergency Medicine.  </a:t>
            </a:r>
            <a:r>
              <a:rPr lang="en-US" dirty="0"/>
              <a:t>2005;12.1: 85-88</a:t>
            </a:r>
            <a:r>
              <a:rPr lang="en-US"/>
              <a:t>.  DOI</a:t>
            </a:r>
            <a:r>
              <a:rPr lang="en-US" dirty="0"/>
              <a:t>: 10.1197/j.aem.2004.08.045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Riester M and Zavitz J. Intraoral Ultrasound Guided Peritonsillar Abscess Drainage.  The Emergency Medicine Residents' Association. https://www.emra.org/emresident/article/intraoral-ultrasound-guided-peritonsillar-abscess-drainage/. Accessed May 13, 2019. 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/>
              <a:t>Riviello RJ. Otolaryngologic procedures; Tonsil: Peritonsillar Abscess. In: Roberts JR, ed. </a:t>
            </a:r>
            <a:r>
              <a:rPr lang="en-US" i="1" dirty="0"/>
              <a:t>Roberts and Hedges’ Clinical Procedures in Emergency Medicine</a:t>
            </a:r>
            <a:r>
              <a:rPr lang="en-US" dirty="0"/>
              <a:t>. 7th ed. Philadelphia, PA: Elsevier/Saunders; 2019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UpToDate. Peritonsillar Cellulitis and Abscess. https://www.uptodate.com/contents/peritonsillar-cellulitis-and-abscess. Accessed May 13, 2019. 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>
                <a:effectLst/>
              </a:rPr>
              <a:t>Powell EL, </a:t>
            </a:r>
            <a:r>
              <a:rPr lang="en-US" dirty="0"/>
              <a:t>Powell J, </a:t>
            </a:r>
            <a:r>
              <a:rPr lang="en-US" dirty="0">
                <a:effectLst/>
              </a:rPr>
              <a:t> Samuel JR, Wilson JA. “A Review of the Pathogenesis of Adult Peritonsillar Abscess: Time for a Re-Evaluation.” </a:t>
            </a:r>
            <a:r>
              <a:rPr lang="en-US" i="1" dirty="0">
                <a:effectLst/>
              </a:rPr>
              <a:t>Journal of Antimicrobial Chemotherapy</a:t>
            </a:r>
            <a:r>
              <a:rPr lang="en-US" dirty="0">
                <a:effectLst/>
              </a:rPr>
              <a:t> 68, no. 9 (September 1, 2013): 1941–50.  DOI: </a:t>
            </a:r>
            <a:r>
              <a:rPr lang="en-US" dirty="0"/>
              <a:t>10.1093/jac/dkt128.</a:t>
            </a:r>
          </a:p>
        </p:txBody>
      </p:sp>
    </p:spTree>
    <p:extLst>
      <p:ext uri="{BB962C8B-B14F-4D97-AF65-F5344CB8AC3E}">
        <p14:creationId xmlns:p14="http://schemas.microsoft.com/office/powerpoint/2010/main" val="1731020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</TotalTime>
  <Words>951</Words>
  <Application>Microsoft Macintosh PowerPoint</Application>
  <PresentationFormat>Widescreen</PresentationFormat>
  <Paragraphs>66</Paragraphs>
  <Slides>8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eritonsillar Abscess for the Emergency Physician</vt:lpstr>
      <vt:lpstr>Peritonsillar Abscess </vt:lpstr>
      <vt:lpstr>Presentation</vt:lpstr>
      <vt:lpstr>Technique</vt:lpstr>
      <vt:lpstr>PowerPoint Presentation</vt:lpstr>
      <vt:lpstr>Ultrasound</vt:lpstr>
      <vt:lpstr>Disposition</vt:lpstr>
      <vt:lpstr>References: 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eritonsillar Abscess for the Emergency Physician</dc:title>
  <dc:creator>Mustafa Rasheed</dc:creator>
  <cp:lastModifiedBy>Alisa Wray</cp:lastModifiedBy>
  <cp:revision>66</cp:revision>
  <dcterms:created xsi:type="dcterms:W3CDTF">2019-05-16T00:25:24Z</dcterms:created>
  <dcterms:modified xsi:type="dcterms:W3CDTF">2019-12-30T18:30:02Z</dcterms:modified>
</cp:coreProperties>
</file>